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644" y="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ita Slade (Applied Health Research)" userId="a1b63087-25b6-4e2f-8ee3-e05ce4f6fb46" providerId="ADAL" clId="{6A124E99-6556-4837-92F4-A68515A381EA}"/>
    <pc:docChg chg="modSld">
      <pc:chgData name="Anita Slade (Applied Health Research)" userId="a1b63087-25b6-4e2f-8ee3-e05ce4f6fb46" providerId="ADAL" clId="{6A124E99-6556-4837-92F4-A68515A381EA}" dt="2024-03-29T17:30:43.115" v="432" actId="20577"/>
      <pc:docMkLst>
        <pc:docMk/>
      </pc:docMkLst>
      <pc:sldChg chg="modSp mod">
        <pc:chgData name="Anita Slade (Applied Health Research)" userId="a1b63087-25b6-4e2f-8ee3-e05ce4f6fb46" providerId="ADAL" clId="{6A124E99-6556-4837-92F4-A68515A381EA}" dt="2024-03-29T17:30:43.115" v="432" actId="20577"/>
        <pc:sldMkLst>
          <pc:docMk/>
          <pc:sldMk cId="2726932363" sldId="259"/>
        </pc:sldMkLst>
        <pc:spChg chg="mod">
          <ac:chgData name="Anita Slade (Applied Health Research)" userId="a1b63087-25b6-4e2f-8ee3-e05ce4f6fb46" providerId="ADAL" clId="{6A124E99-6556-4837-92F4-A68515A381EA}" dt="2024-03-29T17:30:43.115" v="432" actId="20577"/>
          <ac:spMkLst>
            <pc:docMk/>
            <pc:sldMk cId="2726932363" sldId="259"/>
            <ac:spMk id="3" creationId="{9958DEA3-64BB-69EF-4FB0-67936C9F092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823AC-505A-107B-C452-2522BA6B91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A83AF4-304E-5B33-7F81-5F2A4752D4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2A696-30FD-539A-1474-DA27565FE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89C41-D624-A38D-85FE-DF4974A3D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4CBEEF-25DE-6C8B-20D8-97BE0AC6B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1301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B2161-D175-7917-F070-ECB3D5CCF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787074-5700-69A9-890E-872F9A4CCE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96B62-682E-8A4B-BA49-46A545633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CDBE26-2997-B46D-4849-230B62920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FE62BC-1214-80EE-7940-8D75E6DD0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607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F6B69E-EFA1-B491-6FC5-556643D8C7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22E018-A080-E25F-2464-6CAFC8E1B8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8E6018-C519-6BAF-6432-7B70F7D76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B2D4C-EE5F-9CBA-FDBB-EC3B32C2C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F8D258-370E-C902-8E73-730D03A28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7082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A3880-AF0C-E176-2239-D2D501E967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4EC6AC-3537-F1D6-E869-A3A7A56166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66166A-A990-CA57-7EFA-4687F3C1C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9D16DA-8B61-EA65-96A8-5FB3E3712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F47C2-9BA2-09B0-E681-2A8501DD9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714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90817-8ADF-9744-7C3A-65155FBB6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E03ED0-23AC-697A-D843-DAF333895B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12CE2E-A451-FFE5-E4EF-A79D3F96B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33B5B-9077-3990-D0F1-B6E291193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44B9E5-90DA-D4EB-D74F-4D3F5A057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320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04C89-7EF7-13B1-F128-CC3CE2DDB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1BC99D-F40F-0D00-8989-582B5360D2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97230D-CA35-CD47-427A-241C3B7D24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123393-9187-AD54-5A7B-BD8A248DC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B12414-F2C8-AF7D-8846-934933106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94FB0C-336F-72EB-2F59-45ABA8893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455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28B576-E419-9C89-0801-F7D092F3F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A05986-4132-B64B-7E67-4259BF54B7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B43C82-C59E-7B19-1A9E-8815AD659F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57E804-33F0-1AA5-2EA5-B9B3C8E8F7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9CEDDA-76E1-509D-3648-3C925BA25B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5F681F-BFCE-33F0-6DED-81F9FDFC9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52132F-37FA-0591-CD65-0E39220A3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5F28D4-40F7-0CF5-2666-671ED915F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8769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10963-2A48-66C4-3771-2017B8B98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5CD21D-7A0C-6CA0-EBA5-4F89D27C3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3CA05D-9283-7F66-B98A-308E24B67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58B516-E2CB-267A-2583-D467589D6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6319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C9F35C-1F85-CC86-7552-E83059DB6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FA5BE9-4216-2CEA-B7BD-E630CA1E6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3EABDB-8C43-00A3-B929-E80CFF046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1829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0A5AE-8AE1-D80E-9B41-3B977B39CB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443FC-EC1A-78DC-2157-673CBD9D33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0E9845-0420-11CD-A132-B4342AD07F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0849D0-35C0-EF76-CB04-5B536D22A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11E68F-68C9-3349-236A-863C3E0F2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56EC90-52B4-AD58-6CB3-976EA1B5E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8D71F-F3F9-FCE7-FCC5-B54BF7F6F1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0B917E-B2A1-27B9-8FDC-11E7AF3D64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3669E4-34FA-41CF-E32B-D97296CDA0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2CAA5C-BE25-D0C5-9214-417DEFB8D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84882A-7099-C711-663E-2A557BD8E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4381BA-1D32-52C7-E06A-F5083A0D0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0646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7EE912-9C19-435E-CB30-A50CD3FB5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578ED1-5D4B-DA95-4522-BF8B12183F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E9B3B0-38A4-962B-FC78-2E1919948F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1BAD61-1705-4723-ABE2-19EB383AFC19}" type="datetimeFigureOut">
              <a:rPr lang="en-GB" smtClean="0"/>
              <a:t>29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3F09FE-05E2-474E-FA90-52A17A7316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55D547-16E3-AAD8-4BA4-F9DCFADBA2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43A1A9-D922-4DA9-AEEA-9080575115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7339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B7AAB-0343-6C19-D040-5DEE9F1AB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016000"/>
          </a:xfrm>
        </p:spPr>
        <p:txBody>
          <a:bodyPr>
            <a:normAutofit/>
          </a:bodyPr>
          <a:lstStyle/>
          <a:p>
            <a:r>
              <a:rPr lang="en-GB" sz="2400" dirty="0"/>
              <a:t>Distribution of person and item locations in the Equipment and driveline module</a:t>
            </a:r>
          </a:p>
        </p:txBody>
      </p:sp>
      <p:pic>
        <p:nvPicPr>
          <p:cNvPr id="3" name="Picture 2" descr="A graph of a number of individuals&#10;&#10;Description automatically generated">
            <a:extLst>
              <a:ext uri="{FF2B5EF4-FFF2-40B4-BE49-F238E27FC236}">
                <a16:creationId xmlns:a16="http://schemas.microsoft.com/office/drawing/2014/main" id="{D978EA95-8B9F-7AF3-2249-03E97AC417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267" y="1619250"/>
            <a:ext cx="9615419" cy="4862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643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958DEA3-64BB-69EF-4FB0-67936C9F0926}"/>
              </a:ext>
            </a:extLst>
          </p:cNvPr>
          <p:cNvSpPr txBox="1"/>
          <p:nvPr/>
        </p:nvSpPr>
        <p:spPr>
          <a:xfrm>
            <a:off x="762000" y="630286"/>
            <a:ext cx="10801350" cy="10690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 1 Legend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rgeting of the relative distribution of 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VAD recipients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he item threshold locations on the same logit scale in the final </a:t>
            </a:r>
            <a:r>
              <a:rPr lang="en-GB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GB" sz="1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ipment and driveline module.</a:t>
            </a:r>
          </a:p>
        </p:txBody>
      </p:sp>
    </p:spTree>
    <p:extLst>
      <p:ext uri="{BB962C8B-B14F-4D97-AF65-F5344CB8AC3E}">
        <p14:creationId xmlns:p14="http://schemas.microsoft.com/office/powerpoint/2010/main" val="2726932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1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Distribution of person and item locations in the Equipment and driveline modul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ta Slade (Applied Health Research)</dc:creator>
  <cp:lastModifiedBy>Anita Slade (Applied Health Research)</cp:lastModifiedBy>
  <cp:revision>2</cp:revision>
  <dcterms:created xsi:type="dcterms:W3CDTF">2024-03-13T12:04:49Z</dcterms:created>
  <dcterms:modified xsi:type="dcterms:W3CDTF">2024-03-29T17:30:50Z</dcterms:modified>
</cp:coreProperties>
</file>